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28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0540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8170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8921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0601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1921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9109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4890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5514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5316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1240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0848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DF1C40-F7DE-441A-9300-920500372D82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45DC0E-9537-4240-A689-919AF0CF2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2992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4191000" y="533400"/>
            <a:ext cx="1143000" cy="461665"/>
            <a:chOff x="2909083" y="2400725"/>
            <a:chExt cx="824717" cy="461665"/>
          </a:xfrm>
        </p:grpSpPr>
        <p:sp>
          <p:nvSpPr>
            <p:cNvPr id="6" name="Textfeld 5"/>
            <p:cNvSpPr txBox="1"/>
            <p:nvPr/>
          </p:nvSpPr>
          <p:spPr>
            <a:xfrm>
              <a:off x="2909083" y="2400725"/>
              <a:ext cx="82471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Preleukemic</a:t>
              </a:r>
              <a:endParaRPr lang="de-DE" sz="8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endParaRPr lang="de-DE" sz="8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" name="Gerade Verbindung 6"/>
            <p:cNvCxnSpPr/>
            <p:nvPr/>
          </p:nvCxnSpPr>
          <p:spPr>
            <a:xfrm>
              <a:off x="2953389" y="2476504"/>
              <a:ext cx="0" cy="76283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Gerade Verbindung 7"/>
            <p:cNvCxnSpPr/>
            <p:nvPr/>
          </p:nvCxnSpPr>
          <p:spPr>
            <a:xfrm>
              <a:off x="2953389" y="2590800"/>
              <a:ext cx="0" cy="76283"/>
            </a:xfrm>
            <a:prstGeom prst="line">
              <a:avLst/>
            </a:prstGeom>
            <a:ln w="31750">
              <a:solidFill>
                <a:schemeClr val="tx2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Gerade Verbindung 8"/>
            <p:cNvCxnSpPr/>
            <p:nvPr/>
          </p:nvCxnSpPr>
          <p:spPr>
            <a:xfrm>
              <a:off x="2953389" y="2714979"/>
              <a:ext cx="0" cy="76283"/>
            </a:xfrm>
            <a:prstGeom prst="line">
              <a:avLst/>
            </a:prstGeom>
            <a:ln w="317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feld 1"/>
          <p:cNvSpPr txBox="1"/>
          <p:nvPr/>
        </p:nvSpPr>
        <p:spPr>
          <a:xfrm>
            <a:off x="228600" y="87868"/>
            <a:ext cx="6781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Additional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data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l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2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Hypomethylated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probes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in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PU.1-kd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ompared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to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PU.1-wt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animals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533400"/>
            <a:ext cx="3657600" cy="3657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hteck 3"/>
          <p:cNvSpPr/>
          <p:nvPr/>
        </p:nvSpPr>
        <p:spPr>
          <a:xfrm>
            <a:off x="407436" y="4343400"/>
            <a:ext cx="660296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Arial" pitchFamily="34" charset="0"/>
                <a:cs typeface="Arial" pitchFamily="34" charset="0"/>
              </a:rPr>
              <a:t>Circus plot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displaying the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hypomethylated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probes in PU.1-kd animals. The outer circle represents the different G-banded mouse chromosomes, lines in the inner circles depict significantly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hypomethylated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probes of the different disease stages (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preleukemic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early leukemic and late leukemic from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inner 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to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outer). 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907691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DKF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onnet</dc:creator>
  <cp:lastModifiedBy>sonnet</cp:lastModifiedBy>
  <cp:revision>12</cp:revision>
  <dcterms:created xsi:type="dcterms:W3CDTF">2013-01-25T09:59:08Z</dcterms:created>
  <dcterms:modified xsi:type="dcterms:W3CDTF">2013-03-26T07:36:08Z</dcterms:modified>
</cp:coreProperties>
</file>